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7" r:id="rId4"/>
    <p:sldId id="258" r:id="rId5"/>
    <p:sldId id="261" r:id="rId6"/>
    <p:sldId id="263" r:id="rId7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79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660" y="96"/>
      </p:cViewPr>
      <p:guideLst>
        <p:guide orient="horz" pos="1979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53C3EB8-8B5A-6480-E941-D38D2578A4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9F9C4CAB-35D5-4573-0873-BBFB10B138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A1349D0-9748-0D5E-5E59-82D7B2FC43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1B7483E-F118-1A30-3786-B3044FDB79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B06C90F-EAC3-4F16-1DEE-1698A58FFC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30319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F212BEE-9CC7-51EB-C9CA-40F33D6787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720E6F8F-E9E8-B2E9-FF4E-496B94633C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D045731-6C6D-1E92-E6BF-41AB4B605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155D7D8-1A81-D2AF-EBC6-FBF857B1D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CFD119C-0274-0202-823E-43CB8FA22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23134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56121E7-74DA-F4E6-A094-0805377E0E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F27D7F7E-0BAA-33C7-0D6B-AA3F698383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B4BDB70-18C6-3CE5-C0CC-477FABC818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58D2504-5309-5360-24BC-F1263E39D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70D9EB8-F95F-1DC0-DF10-5C6EFC1866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3177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F50CE5D-CE71-3E8B-46ED-7985ED6687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6FB390FE-8335-AB40-C14C-FAA32390F4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577F52DA-E2F9-AF26-6521-38E107639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0F32D72-9F80-903D-3505-FD206384F3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09F765D-5308-B2AD-A9D2-D6226E3870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85158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B3E8F84-B0D9-AE3B-DA27-97899B8CB8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4B1027F-7B67-C451-F82E-D267B975FE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A067942-94C7-2293-AF4C-02D565C84D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6C03629-4956-00CA-394B-6285EE7E9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2660107E-7712-7BA7-D4AB-FDB31307B0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89477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62DC30F-55EE-4FD8-B5F6-4EBB082090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5EA0FAB-2CC6-0DF6-FBE6-05E4FB4C31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B747E998-4F23-0854-D814-DBEA23DDF5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1A09C76-CD8B-BD83-5415-9B301C51AE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62D61778-8EDB-A116-C2E2-575229561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8C3450F-41E7-E042-A48B-233ADE93A4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3323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9D44F2-5E06-4105-AC20-72ED5546DE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7460154-719A-A66D-2686-EF236C7022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167A1D34-B59B-19DE-CD4E-E0C386A9FB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F57E533A-AF0B-7C40-CEF7-60DF2195B40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F3BA56AF-5DBA-932B-362D-52772DA752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949CA593-A6DF-C374-174D-8060DAEFC4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4CD8D2A5-67F9-4A2A-1417-BD3B6776DB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C7558ED6-1462-4B78-9B16-CC56C0C395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6130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478F92F-1BC8-DD0A-7B6A-CF5F7733D8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0262A33C-C76A-28E2-FFF9-91D4030590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25971583-6382-DE28-8865-10AD00A86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56A50D68-514A-5414-2D4F-DFCE80617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02160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D051F5C2-FF5D-062D-325A-2E6E352AD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CC407DB0-1085-A24F-1ACC-7CFFF453A6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B44E8935-9B1A-1E14-0DF8-8C737A4144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134888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4CE8D18-C6A0-B815-973F-F351276C61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24ACB52-E10A-6996-B66C-566FAF68F9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9DCB3E2-AF79-9322-21D6-5ECE0CED7D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CC2CFD54-A0F1-F420-8D32-842CFB96F6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1275C72C-B155-6F97-F293-7CA91628B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803A755-927A-5383-ABC7-64FD22088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21694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EA1BDE-CD63-960C-1499-0D59081CF5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CB1780B1-E731-65B0-E27B-87E2BC30B39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ADAB281-A161-9F18-BEF0-EA1AF3A7A8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4777251-617F-E5C1-5335-3D2BF67E9A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E18DB93-7C77-08D0-91D6-50A19D24EE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A67B76C-3F2D-8A40-9664-C714EFBEA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34274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35964B3-2677-5B39-23CA-D2D57F408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194E9FE6-3598-79FB-1C3D-A3FBFEA86C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B96D3C40-9C6B-C4D4-C9CB-9E6D42691DF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24732-B814-4F72-AB2C-3F4773D9BDF9}" type="datetimeFigureOut">
              <a:rPr lang="fr-FR" smtClean="0"/>
              <a:t>16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F5413E7-79E6-0AE0-E801-B37B08C642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90CE2D6-AD65-00EE-6FA1-FA39DCD327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F6D5C1-DD39-4F43-BC46-859BE104759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499112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 descr="Une image contenant texte, blanc&#10;&#10;Description générée automatiquement">
            <a:extLst>
              <a:ext uri="{FF2B5EF4-FFF2-40B4-BE49-F238E27FC236}">
                <a16:creationId xmlns:a16="http://schemas.microsoft.com/office/drawing/2014/main" id="{FC0B9F0D-92C7-99B8-9382-8256C657F7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2519" y="0"/>
            <a:ext cx="5661923" cy="6858000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1FA99F2D-922A-A225-8964-55CE05CA9AE5}"/>
              </a:ext>
            </a:extLst>
          </p:cNvPr>
          <p:cNvSpPr txBox="1"/>
          <p:nvPr/>
        </p:nvSpPr>
        <p:spPr>
          <a:xfrm>
            <a:off x="150125" y="232012"/>
            <a:ext cx="34392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Figure 3A: </a:t>
            </a:r>
            <a:r>
              <a:rPr lang="fr-FR" b="1" dirty="0" err="1"/>
              <a:t>Phospho-Kinase</a:t>
            </a:r>
            <a:r>
              <a:rPr lang="fr-FR" b="1" dirty="0"/>
              <a:t> </a:t>
            </a:r>
            <a:r>
              <a:rPr lang="fr-FR" b="1" dirty="0" err="1"/>
              <a:t>Array</a:t>
            </a:r>
            <a:endParaRPr lang="fr-FR" b="1" dirty="0"/>
          </a:p>
        </p:txBody>
      </p:sp>
    </p:spTree>
    <p:extLst>
      <p:ext uri="{BB962C8B-B14F-4D97-AF65-F5344CB8AC3E}">
        <p14:creationId xmlns:p14="http://schemas.microsoft.com/office/powerpoint/2010/main" val="36416946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C9F9E4C6-78E6-39B5-9E45-216C0C32C89F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4824" y="1357020"/>
            <a:ext cx="4660073" cy="3474288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68D6F081-FE11-4AE8-9B6D-42BA9B35E56D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2686" y="1357020"/>
            <a:ext cx="4994490" cy="3474288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95DE7346-9654-DCE6-0C46-D7E0FB8B8C9F}"/>
              </a:ext>
            </a:extLst>
          </p:cNvPr>
          <p:cNvSpPr txBox="1"/>
          <p:nvPr/>
        </p:nvSpPr>
        <p:spPr>
          <a:xfrm>
            <a:off x="2113011" y="4954419"/>
            <a:ext cx="2347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ERK T (42-44 KDa)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E31F6B11-8C9B-57F0-5C09-F6FF2BD58B0A}"/>
              </a:ext>
            </a:extLst>
          </p:cNvPr>
          <p:cNvSpPr txBox="1"/>
          <p:nvPr/>
        </p:nvSpPr>
        <p:spPr>
          <a:xfrm>
            <a:off x="8183179" y="4996134"/>
            <a:ext cx="2347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P ERK (42-44 KDa)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4D4D2A4C-EF57-5B5F-00B0-6679C3CB7C8C}"/>
              </a:ext>
            </a:extLst>
          </p:cNvPr>
          <p:cNvSpPr txBox="1"/>
          <p:nvPr/>
        </p:nvSpPr>
        <p:spPr>
          <a:xfrm rot="18901592">
            <a:off x="1358180" y="933811"/>
            <a:ext cx="73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Susp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A8733F36-B077-1364-D8DC-520AB4A0C726}"/>
              </a:ext>
            </a:extLst>
          </p:cNvPr>
          <p:cNvSpPr txBox="1"/>
          <p:nvPr/>
        </p:nvSpPr>
        <p:spPr>
          <a:xfrm rot="18997719">
            <a:off x="1875298" y="907768"/>
            <a:ext cx="875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PMA 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1B5084EC-01F8-B830-97EA-3D19A18DA924}"/>
              </a:ext>
            </a:extLst>
          </p:cNvPr>
          <p:cNvSpPr txBox="1"/>
          <p:nvPr/>
        </p:nvSpPr>
        <p:spPr>
          <a:xfrm rot="19279151">
            <a:off x="2267495" y="599550"/>
            <a:ext cx="18910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uM  EGCG</a:t>
            </a: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0A1CD2B0-0171-DE41-53AF-0B8E9C2A6289}"/>
              </a:ext>
            </a:extLst>
          </p:cNvPr>
          <p:cNvSpPr txBox="1"/>
          <p:nvPr/>
        </p:nvSpPr>
        <p:spPr>
          <a:xfrm rot="19231905">
            <a:off x="2849227" y="547544"/>
            <a:ext cx="19943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uM  EGCG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2D30E624-9405-9B55-D431-27A8AF217B9F}"/>
              </a:ext>
            </a:extLst>
          </p:cNvPr>
          <p:cNvSpPr txBox="1"/>
          <p:nvPr/>
        </p:nvSpPr>
        <p:spPr>
          <a:xfrm rot="19231905">
            <a:off x="3411524" y="542480"/>
            <a:ext cx="20102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0uM  EGCG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BEA0A84D-8822-836F-970C-B678BCAC6B8C}"/>
              </a:ext>
            </a:extLst>
          </p:cNvPr>
          <p:cNvSpPr txBox="1"/>
          <p:nvPr/>
        </p:nvSpPr>
        <p:spPr>
          <a:xfrm rot="19231905">
            <a:off x="4004568" y="608485"/>
            <a:ext cx="19792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0uM  EGCG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07A4D237-1571-8671-B1A2-72AE2F2B0E60}"/>
              </a:ext>
            </a:extLst>
          </p:cNvPr>
          <p:cNvSpPr txBox="1"/>
          <p:nvPr/>
        </p:nvSpPr>
        <p:spPr>
          <a:xfrm>
            <a:off x="6866740" y="1535265"/>
            <a:ext cx="9328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KDa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8167D491-3133-011E-4736-D0D9F18325D2}"/>
              </a:ext>
            </a:extLst>
          </p:cNvPr>
          <p:cNvSpPr txBox="1"/>
          <p:nvPr/>
        </p:nvSpPr>
        <p:spPr>
          <a:xfrm>
            <a:off x="849681" y="1049243"/>
            <a:ext cx="6562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KDa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55AD9F43-9D54-69BA-7C70-3790F98B7B2F}"/>
              </a:ext>
            </a:extLst>
          </p:cNvPr>
          <p:cNvSpPr txBox="1"/>
          <p:nvPr/>
        </p:nvSpPr>
        <p:spPr>
          <a:xfrm rot="18901592">
            <a:off x="7321182" y="952576"/>
            <a:ext cx="73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Susp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67F0582B-8A45-CF27-892F-F995E3E1D99C}"/>
              </a:ext>
            </a:extLst>
          </p:cNvPr>
          <p:cNvSpPr txBox="1"/>
          <p:nvPr/>
        </p:nvSpPr>
        <p:spPr>
          <a:xfrm rot="18997719">
            <a:off x="7785754" y="883477"/>
            <a:ext cx="875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PMA 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09A748CA-73D3-4878-8CF5-EFA0E3C460E0}"/>
              </a:ext>
            </a:extLst>
          </p:cNvPr>
          <p:cNvSpPr txBox="1"/>
          <p:nvPr/>
        </p:nvSpPr>
        <p:spPr>
          <a:xfrm rot="19279151">
            <a:off x="8051531" y="607899"/>
            <a:ext cx="18910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uM  EGCG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10BAFDA8-FB1E-7FD3-7362-ABC15ED93924}"/>
              </a:ext>
            </a:extLst>
          </p:cNvPr>
          <p:cNvSpPr txBox="1"/>
          <p:nvPr/>
        </p:nvSpPr>
        <p:spPr>
          <a:xfrm rot="19231905">
            <a:off x="8665819" y="513497"/>
            <a:ext cx="19943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uM  EGCG</a:t>
            </a:r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CE0E24C7-7B6B-71B3-A498-67E4EE19E165}"/>
              </a:ext>
            </a:extLst>
          </p:cNvPr>
          <p:cNvSpPr txBox="1"/>
          <p:nvPr/>
        </p:nvSpPr>
        <p:spPr>
          <a:xfrm rot="19231905">
            <a:off x="9185214" y="465062"/>
            <a:ext cx="20102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0uM  EGCG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4F99101C-CCBF-28D6-D6D1-16AB0518F990}"/>
              </a:ext>
            </a:extLst>
          </p:cNvPr>
          <p:cNvSpPr txBox="1"/>
          <p:nvPr/>
        </p:nvSpPr>
        <p:spPr>
          <a:xfrm rot="19231905">
            <a:off x="9670069" y="571128"/>
            <a:ext cx="19792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0uM  EGCG</a:t>
            </a:r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26578FC5-1654-4BF1-F88B-FC7FAD8AB18B}"/>
              </a:ext>
            </a:extLst>
          </p:cNvPr>
          <p:cNvSpPr txBox="1"/>
          <p:nvPr/>
        </p:nvSpPr>
        <p:spPr>
          <a:xfrm>
            <a:off x="6909326" y="1112256"/>
            <a:ext cx="6562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KDa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15DBDC9D-3B8F-2944-3590-DEFE35040393}"/>
              </a:ext>
            </a:extLst>
          </p:cNvPr>
          <p:cNvSpPr txBox="1"/>
          <p:nvPr/>
        </p:nvSpPr>
        <p:spPr>
          <a:xfrm>
            <a:off x="122830" y="150125"/>
            <a:ext cx="1955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Figure 3C</a:t>
            </a:r>
          </a:p>
        </p:txBody>
      </p:sp>
    </p:spTree>
    <p:extLst>
      <p:ext uri="{BB962C8B-B14F-4D97-AF65-F5344CB8AC3E}">
        <p14:creationId xmlns:p14="http://schemas.microsoft.com/office/powerpoint/2010/main" val="34210916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 6">
            <a:extLst>
              <a:ext uri="{FF2B5EF4-FFF2-40B4-BE49-F238E27FC236}">
                <a16:creationId xmlns:a16="http://schemas.microsoft.com/office/drawing/2014/main" id="{BB7EB209-BB2F-288A-8221-5EFD0BA5454E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7446217" y="1250204"/>
            <a:ext cx="3419856" cy="2549652"/>
          </a:xfrm>
          <a:prstGeom prst="rect">
            <a:avLst/>
          </a:prstGeom>
        </p:spPr>
      </p:pic>
      <p:pic>
        <p:nvPicPr>
          <p:cNvPr id="14" name="Image 13" descr="Une image contenant texte, appareil, blanc&#10;&#10;Description générée automatiquement">
            <a:extLst>
              <a:ext uri="{FF2B5EF4-FFF2-40B4-BE49-F238E27FC236}">
                <a16:creationId xmlns:a16="http://schemas.microsoft.com/office/drawing/2014/main" id="{176F49BC-2F80-C2C9-2053-C8602CEE4E1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6819" y="3799856"/>
            <a:ext cx="3419856" cy="2548128"/>
          </a:xfrm>
          <a:prstGeom prst="rect">
            <a:avLst/>
          </a:prstGeom>
        </p:spPr>
      </p:pic>
      <p:pic>
        <p:nvPicPr>
          <p:cNvPr id="24" name="Image 23" descr="Une image contenant texte, blanc&#10;&#10;Description générée automatiquement">
            <a:extLst>
              <a:ext uri="{FF2B5EF4-FFF2-40B4-BE49-F238E27FC236}">
                <a16:creationId xmlns:a16="http://schemas.microsoft.com/office/drawing/2014/main" id="{B5B49DC8-4EF9-58E8-DC38-57626C594B3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4038" y="1652099"/>
            <a:ext cx="3508248" cy="2667000"/>
          </a:xfrm>
          <a:prstGeom prst="rect">
            <a:avLst/>
          </a:prstGeom>
        </p:spPr>
      </p:pic>
      <p:sp>
        <p:nvSpPr>
          <p:cNvPr id="27" name="ZoneTexte 26">
            <a:extLst>
              <a:ext uri="{FF2B5EF4-FFF2-40B4-BE49-F238E27FC236}">
                <a16:creationId xmlns:a16="http://schemas.microsoft.com/office/drawing/2014/main" id="{3CE738B5-6A17-D342-2673-2694B62D9375}"/>
              </a:ext>
            </a:extLst>
          </p:cNvPr>
          <p:cNvSpPr txBox="1"/>
          <p:nvPr/>
        </p:nvSpPr>
        <p:spPr>
          <a:xfrm>
            <a:off x="2117892" y="4427589"/>
            <a:ext cx="301366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  GSK 3</a:t>
            </a:r>
            <a:r>
              <a:rPr lang="el-GR" b="1" dirty="0"/>
              <a:t>α</a:t>
            </a:r>
            <a:r>
              <a:rPr lang="fr-FR" b="1" dirty="0"/>
              <a:t>/</a:t>
            </a:r>
            <a:r>
              <a:rPr lang="el-GR" b="1" dirty="0"/>
              <a:t>β</a:t>
            </a:r>
            <a:r>
              <a:rPr lang="fr-FR" b="1" dirty="0"/>
              <a:t> (s21/s9) 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21FB1BE9-76F8-2295-FAAE-63AB6123A6A1}"/>
              </a:ext>
            </a:extLst>
          </p:cNvPr>
          <p:cNvSpPr txBox="1"/>
          <p:nvPr/>
        </p:nvSpPr>
        <p:spPr>
          <a:xfrm>
            <a:off x="8281124" y="6112919"/>
            <a:ext cx="24733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P-GSK 3</a:t>
            </a:r>
            <a:r>
              <a:rPr lang="el-GR" b="1" dirty="0"/>
              <a:t>α</a:t>
            </a:r>
            <a:r>
              <a:rPr lang="fr-FR" b="1" dirty="0"/>
              <a:t>/</a:t>
            </a:r>
            <a:r>
              <a:rPr lang="el-GR" b="1" dirty="0"/>
              <a:t>β</a:t>
            </a:r>
            <a:r>
              <a:rPr lang="fr-FR" b="1" dirty="0"/>
              <a:t> (s21/s9) </a:t>
            </a:r>
          </a:p>
          <a:p>
            <a:endParaRPr lang="fr-FR" dirty="0"/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76AE858F-7591-8168-2A78-4B41CE05B7D3}"/>
              </a:ext>
            </a:extLst>
          </p:cNvPr>
          <p:cNvSpPr txBox="1"/>
          <p:nvPr/>
        </p:nvSpPr>
        <p:spPr>
          <a:xfrm>
            <a:off x="4115167" y="4319099"/>
            <a:ext cx="101639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51 kDa</a:t>
            </a:r>
          </a:p>
          <a:p>
            <a:r>
              <a:rPr lang="fr-FR" b="1" dirty="0"/>
              <a:t>46 kDa</a:t>
            </a:r>
            <a:endParaRPr lang="fr-FR" dirty="0"/>
          </a:p>
        </p:txBody>
      </p:sp>
      <p:sp>
        <p:nvSpPr>
          <p:cNvPr id="35" name="ZoneTexte 34">
            <a:extLst>
              <a:ext uri="{FF2B5EF4-FFF2-40B4-BE49-F238E27FC236}">
                <a16:creationId xmlns:a16="http://schemas.microsoft.com/office/drawing/2014/main" id="{E55C8108-0F82-FB37-DF2B-D5534004832B}"/>
              </a:ext>
            </a:extLst>
          </p:cNvPr>
          <p:cNvSpPr txBox="1"/>
          <p:nvPr/>
        </p:nvSpPr>
        <p:spPr>
          <a:xfrm>
            <a:off x="10876675" y="2107245"/>
            <a:ext cx="101639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51 kDa</a:t>
            </a:r>
          </a:p>
          <a:p>
            <a:r>
              <a:rPr lang="fr-FR" b="1" dirty="0"/>
              <a:t>46 kDa</a:t>
            </a:r>
            <a:endParaRPr lang="fr-FR" dirty="0"/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BF43897A-6905-9828-C949-84ED577031F8}"/>
              </a:ext>
            </a:extLst>
          </p:cNvPr>
          <p:cNvSpPr txBox="1"/>
          <p:nvPr/>
        </p:nvSpPr>
        <p:spPr>
          <a:xfrm>
            <a:off x="10866073" y="4635316"/>
            <a:ext cx="1016391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51 kDa</a:t>
            </a:r>
          </a:p>
          <a:p>
            <a:r>
              <a:rPr lang="fr-FR" b="1" dirty="0"/>
              <a:t>46 kDa</a:t>
            </a:r>
            <a:endParaRPr lang="fr-FR" dirty="0"/>
          </a:p>
        </p:txBody>
      </p:sp>
      <p:sp>
        <p:nvSpPr>
          <p:cNvPr id="39" name="ZoneTexte 38">
            <a:extLst>
              <a:ext uri="{FF2B5EF4-FFF2-40B4-BE49-F238E27FC236}">
                <a16:creationId xmlns:a16="http://schemas.microsoft.com/office/drawing/2014/main" id="{BF3CE7A2-FBD0-1306-6C84-FC610EE1597D}"/>
              </a:ext>
            </a:extLst>
          </p:cNvPr>
          <p:cNvSpPr txBox="1"/>
          <p:nvPr/>
        </p:nvSpPr>
        <p:spPr>
          <a:xfrm rot="18901592">
            <a:off x="2611546" y="1111831"/>
            <a:ext cx="73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Susp</a:t>
            </a:r>
          </a:p>
        </p:txBody>
      </p:sp>
      <p:sp>
        <p:nvSpPr>
          <p:cNvPr id="41" name="ZoneTexte 40">
            <a:extLst>
              <a:ext uri="{FF2B5EF4-FFF2-40B4-BE49-F238E27FC236}">
                <a16:creationId xmlns:a16="http://schemas.microsoft.com/office/drawing/2014/main" id="{FC29D6F4-B462-5538-70E7-CDAE4168734A}"/>
              </a:ext>
            </a:extLst>
          </p:cNvPr>
          <p:cNvSpPr txBox="1"/>
          <p:nvPr/>
        </p:nvSpPr>
        <p:spPr>
          <a:xfrm rot="18997719">
            <a:off x="2966004" y="1130463"/>
            <a:ext cx="875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PMA </a:t>
            </a:r>
          </a:p>
        </p:txBody>
      </p:sp>
      <p:sp>
        <p:nvSpPr>
          <p:cNvPr id="43" name="ZoneTexte 42">
            <a:extLst>
              <a:ext uri="{FF2B5EF4-FFF2-40B4-BE49-F238E27FC236}">
                <a16:creationId xmlns:a16="http://schemas.microsoft.com/office/drawing/2014/main" id="{30CD3AC6-96CE-F34B-3EDA-48E8C8F456AF}"/>
              </a:ext>
            </a:extLst>
          </p:cNvPr>
          <p:cNvSpPr txBox="1"/>
          <p:nvPr/>
        </p:nvSpPr>
        <p:spPr>
          <a:xfrm rot="19279151">
            <a:off x="3182759" y="885568"/>
            <a:ext cx="18910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uM  EGCG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88A706AC-1DEF-583B-843C-AE340D55CDC9}"/>
              </a:ext>
            </a:extLst>
          </p:cNvPr>
          <p:cNvSpPr txBox="1"/>
          <p:nvPr/>
        </p:nvSpPr>
        <p:spPr>
          <a:xfrm rot="19231905">
            <a:off x="3609972" y="896137"/>
            <a:ext cx="19943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uM  EGCG</a:t>
            </a:r>
          </a:p>
        </p:txBody>
      </p:sp>
      <p:sp>
        <p:nvSpPr>
          <p:cNvPr id="47" name="ZoneTexte 46">
            <a:extLst>
              <a:ext uri="{FF2B5EF4-FFF2-40B4-BE49-F238E27FC236}">
                <a16:creationId xmlns:a16="http://schemas.microsoft.com/office/drawing/2014/main" id="{80ED6014-7DD4-B12A-93BF-A288A61C502E}"/>
              </a:ext>
            </a:extLst>
          </p:cNvPr>
          <p:cNvSpPr txBox="1"/>
          <p:nvPr/>
        </p:nvSpPr>
        <p:spPr>
          <a:xfrm rot="19231905">
            <a:off x="3954050" y="922082"/>
            <a:ext cx="20102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0uM  EGCG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B008871E-4591-8F63-DCFF-1DBD133E6897}"/>
              </a:ext>
            </a:extLst>
          </p:cNvPr>
          <p:cNvSpPr txBox="1"/>
          <p:nvPr/>
        </p:nvSpPr>
        <p:spPr>
          <a:xfrm rot="19231905">
            <a:off x="4363352" y="979311"/>
            <a:ext cx="19792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0uM  EGCG</a:t>
            </a:r>
          </a:p>
        </p:txBody>
      </p:sp>
      <p:sp>
        <p:nvSpPr>
          <p:cNvPr id="51" name="ZoneTexte 50">
            <a:extLst>
              <a:ext uri="{FF2B5EF4-FFF2-40B4-BE49-F238E27FC236}">
                <a16:creationId xmlns:a16="http://schemas.microsoft.com/office/drawing/2014/main" id="{456545E7-7E2B-F068-1CDB-2DA896BCBAC6}"/>
              </a:ext>
            </a:extLst>
          </p:cNvPr>
          <p:cNvSpPr txBox="1"/>
          <p:nvPr/>
        </p:nvSpPr>
        <p:spPr>
          <a:xfrm rot="18901592">
            <a:off x="8127640" y="673958"/>
            <a:ext cx="73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Susp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BB8EB487-6C1C-3918-897F-C41FA1D4CECE}"/>
              </a:ext>
            </a:extLst>
          </p:cNvPr>
          <p:cNvSpPr txBox="1"/>
          <p:nvPr/>
        </p:nvSpPr>
        <p:spPr>
          <a:xfrm rot="18997719">
            <a:off x="8482098" y="692590"/>
            <a:ext cx="875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PMA </a:t>
            </a:r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5CDC9F37-2AAA-55E3-9746-A164217DCEFE}"/>
              </a:ext>
            </a:extLst>
          </p:cNvPr>
          <p:cNvSpPr txBox="1"/>
          <p:nvPr/>
        </p:nvSpPr>
        <p:spPr>
          <a:xfrm rot="19279151">
            <a:off x="8698853" y="447695"/>
            <a:ext cx="18910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uM  EGCG</a:t>
            </a:r>
          </a:p>
        </p:txBody>
      </p:sp>
      <p:sp>
        <p:nvSpPr>
          <p:cNvPr id="57" name="ZoneTexte 56">
            <a:extLst>
              <a:ext uri="{FF2B5EF4-FFF2-40B4-BE49-F238E27FC236}">
                <a16:creationId xmlns:a16="http://schemas.microsoft.com/office/drawing/2014/main" id="{30DB5E9C-D69E-CA4F-03A4-22A9C92276B3}"/>
              </a:ext>
            </a:extLst>
          </p:cNvPr>
          <p:cNvSpPr txBox="1"/>
          <p:nvPr/>
        </p:nvSpPr>
        <p:spPr>
          <a:xfrm rot="19231905">
            <a:off x="9126066" y="458264"/>
            <a:ext cx="19943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uM  EGCG</a:t>
            </a:r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24CC68C9-8AE3-E6FF-93DB-2B73A77259FF}"/>
              </a:ext>
            </a:extLst>
          </p:cNvPr>
          <p:cNvSpPr txBox="1"/>
          <p:nvPr/>
        </p:nvSpPr>
        <p:spPr>
          <a:xfrm rot="19231905">
            <a:off x="9470144" y="484209"/>
            <a:ext cx="20102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0uM  EGCG</a:t>
            </a: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396E2C33-833F-C5EE-6EDA-48C6A483E26D}"/>
              </a:ext>
            </a:extLst>
          </p:cNvPr>
          <p:cNvSpPr txBox="1"/>
          <p:nvPr/>
        </p:nvSpPr>
        <p:spPr>
          <a:xfrm rot="19231905">
            <a:off x="9879446" y="541438"/>
            <a:ext cx="19792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0uM  EGCG</a:t>
            </a:r>
          </a:p>
        </p:txBody>
      </p:sp>
      <p:sp>
        <p:nvSpPr>
          <p:cNvPr id="63" name="ZoneTexte 62">
            <a:extLst>
              <a:ext uri="{FF2B5EF4-FFF2-40B4-BE49-F238E27FC236}">
                <a16:creationId xmlns:a16="http://schemas.microsoft.com/office/drawing/2014/main" id="{46F20612-53F9-1FE3-5AC0-088D8A7C4F0C}"/>
              </a:ext>
            </a:extLst>
          </p:cNvPr>
          <p:cNvSpPr txBox="1"/>
          <p:nvPr/>
        </p:nvSpPr>
        <p:spPr>
          <a:xfrm>
            <a:off x="7786006" y="915834"/>
            <a:ext cx="6562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KDa</a:t>
            </a:r>
          </a:p>
        </p:txBody>
      </p:sp>
      <p:sp>
        <p:nvSpPr>
          <p:cNvPr id="65" name="ZoneTexte 64">
            <a:extLst>
              <a:ext uri="{FF2B5EF4-FFF2-40B4-BE49-F238E27FC236}">
                <a16:creationId xmlns:a16="http://schemas.microsoft.com/office/drawing/2014/main" id="{6DC1F76D-3752-259B-F485-8D19A4948AFD}"/>
              </a:ext>
            </a:extLst>
          </p:cNvPr>
          <p:cNvSpPr txBox="1"/>
          <p:nvPr/>
        </p:nvSpPr>
        <p:spPr>
          <a:xfrm>
            <a:off x="2260901" y="1411369"/>
            <a:ext cx="6562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KDa</a:t>
            </a:r>
          </a:p>
        </p:txBody>
      </p:sp>
      <p:sp>
        <p:nvSpPr>
          <p:cNvPr id="67" name="ZoneTexte 66">
            <a:extLst>
              <a:ext uri="{FF2B5EF4-FFF2-40B4-BE49-F238E27FC236}">
                <a16:creationId xmlns:a16="http://schemas.microsoft.com/office/drawing/2014/main" id="{9717B77A-F03F-13C6-9B65-59C5AAA51B0B}"/>
              </a:ext>
            </a:extLst>
          </p:cNvPr>
          <p:cNvSpPr txBox="1"/>
          <p:nvPr/>
        </p:nvSpPr>
        <p:spPr>
          <a:xfrm>
            <a:off x="265338" y="251622"/>
            <a:ext cx="16685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Figure 3C</a:t>
            </a:r>
          </a:p>
        </p:txBody>
      </p:sp>
    </p:spTree>
    <p:extLst>
      <p:ext uri="{BB962C8B-B14F-4D97-AF65-F5344CB8AC3E}">
        <p14:creationId xmlns:p14="http://schemas.microsoft.com/office/powerpoint/2010/main" val="2865727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26A611F0-4FB8-A7B0-36B9-7853C31FDC54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66926" y="2319666"/>
            <a:ext cx="4430382" cy="3303043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53FECF28-E7AD-5479-4CFA-44B68B848E0E}"/>
              </a:ext>
            </a:extLst>
          </p:cNvPr>
          <p:cNvSpPr txBox="1"/>
          <p:nvPr/>
        </p:nvSpPr>
        <p:spPr>
          <a:xfrm>
            <a:off x="8446637" y="5622709"/>
            <a:ext cx="1608675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P-RSK 1/2/3 </a:t>
            </a:r>
            <a:r>
              <a:rPr lang="fr-FR" sz="1400" b="1" dirty="0"/>
              <a:t>(s380/s386/s377</a:t>
            </a:r>
            <a:r>
              <a:rPr lang="fr-FR" sz="1200" b="1" dirty="0"/>
              <a:t>)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270C8F24-4A29-7EBA-C841-F181E9F7258B}"/>
              </a:ext>
            </a:extLst>
          </p:cNvPr>
          <p:cNvSpPr txBox="1"/>
          <p:nvPr/>
        </p:nvSpPr>
        <p:spPr>
          <a:xfrm>
            <a:off x="10055312" y="5708060"/>
            <a:ext cx="8521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90 kDa</a:t>
            </a:r>
            <a:endParaRPr lang="fr-FR" dirty="0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9CD2E0C4-FACA-AF46-C8EB-BE3255CB51BF}"/>
              </a:ext>
            </a:extLst>
          </p:cNvPr>
          <p:cNvSpPr txBox="1"/>
          <p:nvPr/>
        </p:nvSpPr>
        <p:spPr>
          <a:xfrm rot="18901592">
            <a:off x="7632250" y="1819767"/>
            <a:ext cx="73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Susp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022A3876-F84C-4EC4-F6DF-4AF810C5DB42}"/>
              </a:ext>
            </a:extLst>
          </p:cNvPr>
          <p:cNvSpPr txBox="1"/>
          <p:nvPr/>
        </p:nvSpPr>
        <p:spPr>
          <a:xfrm rot="18997719">
            <a:off x="8014093" y="1808186"/>
            <a:ext cx="875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PMA 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FEE8770A-EB1E-A4CC-2036-CB7D71FCDF8B}"/>
              </a:ext>
            </a:extLst>
          </p:cNvPr>
          <p:cNvSpPr txBox="1"/>
          <p:nvPr/>
        </p:nvSpPr>
        <p:spPr>
          <a:xfrm rot="19279151">
            <a:off x="8290394" y="1521606"/>
            <a:ext cx="18910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uM  EGCG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3F68C530-6A35-E6AC-F342-0FE4EC6F2B19}"/>
              </a:ext>
            </a:extLst>
          </p:cNvPr>
          <p:cNvSpPr txBox="1"/>
          <p:nvPr/>
        </p:nvSpPr>
        <p:spPr>
          <a:xfrm rot="19231905">
            <a:off x="8670546" y="1464523"/>
            <a:ext cx="19943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uM  EGCG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E6C423C0-E5E7-5A13-6585-AA3FA0C45DE3}"/>
              </a:ext>
            </a:extLst>
          </p:cNvPr>
          <p:cNvSpPr txBox="1"/>
          <p:nvPr/>
        </p:nvSpPr>
        <p:spPr>
          <a:xfrm rot="19231905">
            <a:off x="9104551" y="1488157"/>
            <a:ext cx="20102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0uM  EGCG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CF68FE56-961F-7FA5-EF4E-B0BB22F8F227}"/>
              </a:ext>
            </a:extLst>
          </p:cNvPr>
          <p:cNvSpPr txBox="1"/>
          <p:nvPr/>
        </p:nvSpPr>
        <p:spPr>
          <a:xfrm rot="19231905">
            <a:off x="9507486" y="1521219"/>
            <a:ext cx="19792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0uM  EGCG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1B0F6255-8FFD-7ABB-5C15-80DA724AB8FF}"/>
              </a:ext>
            </a:extLst>
          </p:cNvPr>
          <p:cNvSpPr txBox="1"/>
          <p:nvPr/>
        </p:nvSpPr>
        <p:spPr>
          <a:xfrm>
            <a:off x="7086343" y="2011136"/>
            <a:ext cx="6562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KDa</a:t>
            </a:r>
          </a:p>
        </p:txBody>
      </p:sp>
      <p:pic>
        <p:nvPicPr>
          <p:cNvPr id="34" name="Image 33" descr="Une image contenant blanc&#10;&#10;Description générée automatiquement">
            <a:extLst>
              <a:ext uri="{FF2B5EF4-FFF2-40B4-BE49-F238E27FC236}">
                <a16:creationId xmlns:a16="http://schemas.microsoft.com/office/drawing/2014/main" id="{9F01C210-C659-D082-5944-E8F6700CA41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740"/>
          <a:stretch/>
        </p:blipFill>
        <p:spPr>
          <a:xfrm>
            <a:off x="833137" y="1430353"/>
            <a:ext cx="4012612" cy="2012454"/>
          </a:xfrm>
          <a:prstGeom prst="rect">
            <a:avLst/>
          </a:prstGeom>
        </p:spPr>
      </p:pic>
      <p:pic>
        <p:nvPicPr>
          <p:cNvPr id="36" name="Image 35" descr="Une image contenant appareil, blanc, four, vieux&#10;&#10;Description générée automatiquement">
            <a:extLst>
              <a:ext uri="{FF2B5EF4-FFF2-40B4-BE49-F238E27FC236}">
                <a16:creationId xmlns:a16="http://schemas.microsoft.com/office/drawing/2014/main" id="{9D85713B-FB12-647C-F3F4-39DD75AF6D7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037" r="456"/>
          <a:stretch/>
        </p:blipFill>
        <p:spPr>
          <a:xfrm>
            <a:off x="833137" y="3766782"/>
            <a:ext cx="4012612" cy="2012453"/>
          </a:xfrm>
          <a:prstGeom prst="rect">
            <a:avLst/>
          </a:prstGeom>
        </p:spPr>
      </p:pic>
      <p:sp>
        <p:nvSpPr>
          <p:cNvPr id="38" name="ZoneTexte 37">
            <a:extLst>
              <a:ext uri="{FF2B5EF4-FFF2-40B4-BE49-F238E27FC236}">
                <a16:creationId xmlns:a16="http://schemas.microsoft.com/office/drawing/2014/main" id="{E3ECF8DF-DE9E-F52D-8619-C58E10F79398}"/>
              </a:ext>
            </a:extLst>
          </p:cNvPr>
          <p:cNvSpPr txBox="1"/>
          <p:nvPr/>
        </p:nvSpPr>
        <p:spPr>
          <a:xfrm rot="18901592">
            <a:off x="2024963" y="915009"/>
            <a:ext cx="73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Susp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EFB2010B-A232-E91B-CBC1-668F641F564E}"/>
              </a:ext>
            </a:extLst>
          </p:cNvPr>
          <p:cNvSpPr txBox="1"/>
          <p:nvPr/>
        </p:nvSpPr>
        <p:spPr>
          <a:xfrm rot="18997719">
            <a:off x="2406806" y="903428"/>
            <a:ext cx="875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PMA 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5205E6CB-AE35-A37E-A2B6-F6F6A7E85C46}"/>
              </a:ext>
            </a:extLst>
          </p:cNvPr>
          <p:cNvSpPr txBox="1"/>
          <p:nvPr/>
        </p:nvSpPr>
        <p:spPr>
          <a:xfrm rot="19279151">
            <a:off x="2683107" y="616848"/>
            <a:ext cx="18910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uM  EGCG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693A4BEE-FA27-C9F5-CAF8-D053A09546C0}"/>
              </a:ext>
            </a:extLst>
          </p:cNvPr>
          <p:cNvSpPr txBox="1"/>
          <p:nvPr/>
        </p:nvSpPr>
        <p:spPr>
          <a:xfrm rot="19231905">
            <a:off x="3063259" y="559765"/>
            <a:ext cx="19943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uM  EGCG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FD0BF5EC-EF0F-6AA4-DC79-CD88C0691F15}"/>
              </a:ext>
            </a:extLst>
          </p:cNvPr>
          <p:cNvSpPr txBox="1"/>
          <p:nvPr/>
        </p:nvSpPr>
        <p:spPr>
          <a:xfrm rot="19231905">
            <a:off x="3497264" y="583399"/>
            <a:ext cx="20102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0uM  EGCG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C2DEEFFC-03DA-AD3C-02F1-8B89726C1CB9}"/>
              </a:ext>
            </a:extLst>
          </p:cNvPr>
          <p:cNvSpPr txBox="1"/>
          <p:nvPr/>
        </p:nvSpPr>
        <p:spPr>
          <a:xfrm rot="19231905">
            <a:off x="3900199" y="616461"/>
            <a:ext cx="19792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0uM  EGCG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C7A46ED2-A166-A175-1192-87DD232CAB98}"/>
              </a:ext>
            </a:extLst>
          </p:cNvPr>
          <p:cNvSpPr txBox="1"/>
          <p:nvPr/>
        </p:nvSpPr>
        <p:spPr>
          <a:xfrm>
            <a:off x="1479056" y="1106378"/>
            <a:ext cx="6562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KDa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EB360681-2986-F506-CE10-8684CF242737}"/>
              </a:ext>
            </a:extLst>
          </p:cNvPr>
          <p:cNvSpPr txBox="1"/>
          <p:nvPr/>
        </p:nvSpPr>
        <p:spPr>
          <a:xfrm>
            <a:off x="145954" y="159513"/>
            <a:ext cx="154636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Figure 3C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1F828EBA-9A2F-18AC-2BB5-B0FDB36846C5}"/>
              </a:ext>
            </a:extLst>
          </p:cNvPr>
          <p:cNvSpPr txBox="1"/>
          <p:nvPr/>
        </p:nvSpPr>
        <p:spPr>
          <a:xfrm>
            <a:off x="1951726" y="5427647"/>
            <a:ext cx="2024387" cy="6155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b="1" dirty="0"/>
              <a:t>        </a:t>
            </a:r>
            <a:r>
              <a:rPr lang="fr-FR" b="1" dirty="0"/>
              <a:t>RSK 1/2/3</a:t>
            </a:r>
          </a:p>
          <a:p>
            <a:r>
              <a:rPr lang="fr-FR" sz="1600" b="1" dirty="0"/>
              <a:t> (s380/s386/s377)</a:t>
            </a: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3782A7C5-6B01-92E8-1CE6-F49F5FA52B30}"/>
              </a:ext>
            </a:extLst>
          </p:cNvPr>
          <p:cNvSpPr txBox="1"/>
          <p:nvPr/>
        </p:nvSpPr>
        <p:spPr>
          <a:xfrm>
            <a:off x="3788278" y="5523394"/>
            <a:ext cx="8521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90 kDa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5055077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EF99F300-E090-BD70-105A-5F041E49215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937" r="-6512"/>
          <a:stretch/>
        </p:blipFill>
        <p:spPr>
          <a:xfrm flipH="1">
            <a:off x="470091" y="1874956"/>
            <a:ext cx="5292502" cy="1891649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FB4DC4CF-F1CA-4753-FF39-1BCE6CD71707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9700" y="1061321"/>
            <a:ext cx="5852160" cy="3518917"/>
          </a:xfrm>
          <a:prstGeom prst="rect">
            <a:avLst/>
          </a:prstGeom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7163FC23-76A6-62BA-4E0F-7B03E9D8DB4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9719"/>
          <a:stretch/>
        </p:blipFill>
        <p:spPr>
          <a:xfrm flipH="1">
            <a:off x="682096" y="3720009"/>
            <a:ext cx="4917517" cy="1720458"/>
          </a:xfrm>
          <a:prstGeom prst="rect">
            <a:avLst/>
          </a:prstGeom>
        </p:spPr>
      </p:pic>
      <p:sp>
        <p:nvSpPr>
          <p:cNvPr id="14" name="ZoneTexte 13">
            <a:extLst>
              <a:ext uri="{FF2B5EF4-FFF2-40B4-BE49-F238E27FC236}">
                <a16:creationId xmlns:a16="http://schemas.microsoft.com/office/drawing/2014/main" id="{3CA769DE-34C7-F3B4-0DCF-F327113F5354}"/>
              </a:ext>
            </a:extLst>
          </p:cNvPr>
          <p:cNvSpPr txBox="1"/>
          <p:nvPr/>
        </p:nvSpPr>
        <p:spPr>
          <a:xfrm rot="18901592">
            <a:off x="1873000" y="1389931"/>
            <a:ext cx="73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Susp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64F5BC77-A17A-8997-1F5D-D55561CB9256}"/>
              </a:ext>
            </a:extLst>
          </p:cNvPr>
          <p:cNvSpPr txBox="1"/>
          <p:nvPr/>
        </p:nvSpPr>
        <p:spPr>
          <a:xfrm rot="18997719">
            <a:off x="2254843" y="1378350"/>
            <a:ext cx="875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PMA 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1D0186EA-A292-952B-4D5B-6E0B6A93D80B}"/>
              </a:ext>
            </a:extLst>
          </p:cNvPr>
          <p:cNvSpPr txBox="1"/>
          <p:nvPr/>
        </p:nvSpPr>
        <p:spPr>
          <a:xfrm rot="19279151">
            <a:off x="2531144" y="1091770"/>
            <a:ext cx="18910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uM  EGCG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0C093C3C-7473-8068-2901-E3D3088B6D01}"/>
              </a:ext>
            </a:extLst>
          </p:cNvPr>
          <p:cNvSpPr txBox="1"/>
          <p:nvPr/>
        </p:nvSpPr>
        <p:spPr>
          <a:xfrm rot="19231905">
            <a:off x="2911296" y="1034687"/>
            <a:ext cx="19943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uM  EGCG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C89391D9-A45F-3F2B-F590-92CEBF249CAD}"/>
              </a:ext>
            </a:extLst>
          </p:cNvPr>
          <p:cNvSpPr txBox="1"/>
          <p:nvPr/>
        </p:nvSpPr>
        <p:spPr>
          <a:xfrm rot="19231905">
            <a:off x="3345301" y="1058321"/>
            <a:ext cx="20102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0uM  EGCG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05FE661A-3FF0-027E-64FA-1C38F062830A}"/>
              </a:ext>
            </a:extLst>
          </p:cNvPr>
          <p:cNvSpPr txBox="1"/>
          <p:nvPr/>
        </p:nvSpPr>
        <p:spPr>
          <a:xfrm rot="19231905">
            <a:off x="3748236" y="1091383"/>
            <a:ext cx="19792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0uM  EGCG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B27CD1FF-2660-F1B7-5256-8E3F6FF5C89D}"/>
              </a:ext>
            </a:extLst>
          </p:cNvPr>
          <p:cNvSpPr txBox="1"/>
          <p:nvPr/>
        </p:nvSpPr>
        <p:spPr>
          <a:xfrm>
            <a:off x="1327093" y="1581300"/>
            <a:ext cx="6562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KDa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AE89A024-E676-DB2B-AF27-60DCCF31F599}"/>
              </a:ext>
            </a:extLst>
          </p:cNvPr>
          <p:cNvSpPr txBox="1"/>
          <p:nvPr/>
        </p:nvSpPr>
        <p:spPr>
          <a:xfrm rot="18901592">
            <a:off x="7699055" y="1725959"/>
            <a:ext cx="73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Susp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94DDB200-4542-EE96-26FD-AB3E4DD1D717}"/>
              </a:ext>
            </a:extLst>
          </p:cNvPr>
          <p:cNvSpPr txBox="1"/>
          <p:nvPr/>
        </p:nvSpPr>
        <p:spPr>
          <a:xfrm rot="18997719">
            <a:off x="8080898" y="1714378"/>
            <a:ext cx="875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PMA 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A6775155-98B6-B82E-284C-C1200868C7C6}"/>
              </a:ext>
            </a:extLst>
          </p:cNvPr>
          <p:cNvSpPr txBox="1"/>
          <p:nvPr/>
        </p:nvSpPr>
        <p:spPr>
          <a:xfrm rot="19279151">
            <a:off x="8357199" y="1427798"/>
            <a:ext cx="18910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uM  EGCG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E1602FF7-C1FF-6FDA-4F46-A81682164E1B}"/>
              </a:ext>
            </a:extLst>
          </p:cNvPr>
          <p:cNvSpPr txBox="1"/>
          <p:nvPr/>
        </p:nvSpPr>
        <p:spPr>
          <a:xfrm rot="19231905">
            <a:off x="8901126" y="1342484"/>
            <a:ext cx="19943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uM  EGCG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A2EA3B94-0287-2428-19CC-A54D28467DF2}"/>
              </a:ext>
            </a:extLst>
          </p:cNvPr>
          <p:cNvSpPr txBox="1"/>
          <p:nvPr/>
        </p:nvSpPr>
        <p:spPr>
          <a:xfrm rot="19231905">
            <a:off x="9529058" y="1337421"/>
            <a:ext cx="20102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0uM  EGCG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20E4F776-E2F5-7572-E582-D76F41A3AC24}"/>
              </a:ext>
            </a:extLst>
          </p:cNvPr>
          <p:cNvSpPr txBox="1"/>
          <p:nvPr/>
        </p:nvSpPr>
        <p:spPr>
          <a:xfrm rot="19231905">
            <a:off x="10009997" y="1398875"/>
            <a:ext cx="19792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0uM  EGCG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0F25CBEB-D976-4F17-6791-EFF1A0AF8B99}"/>
              </a:ext>
            </a:extLst>
          </p:cNvPr>
          <p:cNvSpPr txBox="1"/>
          <p:nvPr/>
        </p:nvSpPr>
        <p:spPr>
          <a:xfrm>
            <a:off x="6989410" y="1839224"/>
            <a:ext cx="6562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KDa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98894252-CDF7-55E5-F8F3-F16B381691B8}"/>
              </a:ext>
            </a:extLst>
          </p:cNvPr>
          <p:cNvSpPr txBox="1"/>
          <p:nvPr/>
        </p:nvSpPr>
        <p:spPr>
          <a:xfrm>
            <a:off x="194480" y="109438"/>
            <a:ext cx="17888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Figure 3C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902EE45B-BEA3-47AE-1F7D-B4D60893BFD8}"/>
              </a:ext>
            </a:extLst>
          </p:cNvPr>
          <p:cNvSpPr txBox="1"/>
          <p:nvPr/>
        </p:nvSpPr>
        <p:spPr>
          <a:xfrm>
            <a:off x="8365403" y="3250655"/>
            <a:ext cx="133451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b="1" dirty="0"/>
              <a:t>  </a:t>
            </a:r>
            <a:r>
              <a:rPr lang="fr-FR" b="1" dirty="0"/>
              <a:t>P-MSK ½ </a:t>
            </a:r>
          </a:p>
          <a:p>
            <a:r>
              <a:rPr lang="fr-FR" sz="1400" dirty="0"/>
              <a:t>(s376/s360)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26FB608F-420F-F954-671F-A284CC8C36B0}"/>
              </a:ext>
            </a:extLst>
          </p:cNvPr>
          <p:cNvSpPr txBox="1"/>
          <p:nvPr/>
        </p:nvSpPr>
        <p:spPr>
          <a:xfrm>
            <a:off x="2330764" y="4863964"/>
            <a:ext cx="1334516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b="1" dirty="0"/>
              <a:t>    </a:t>
            </a:r>
            <a:r>
              <a:rPr lang="fr-FR" b="1" dirty="0"/>
              <a:t>MSK 1 </a:t>
            </a:r>
          </a:p>
          <a:p>
            <a:r>
              <a:rPr lang="fr-FR" sz="1400" dirty="0"/>
              <a:t>(s376/s360)</a:t>
            </a:r>
          </a:p>
        </p:txBody>
      </p:sp>
    </p:spTree>
    <p:extLst>
      <p:ext uri="{BB962C8B-B14F-4D97-AF65-F5344CB8AC3E}">
        <p14:creationId xmlns:p14="http://schemas.microsoft.com/office/powerpoint/2010/main" val="23387916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 descr="Une image contenant texte, guitare&#10;&#10;Description générée automatiquement">
            <a:extLst>
              <a:ext uri="{FF2B5EF4-FFF2-40B4-BE49-F238E27FC236}">
                <a16:creationId xmlns:a16="http://schemas.microsoft.com/office/drawing/2014/main" id="{C57F16A9-C5F0-58D3-2267-64DF70DB82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5725" y="1521319"/>
            <a:ext cx="4523606" cy="3370530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73A8E070-9F39-1E1F-DD45-ACDA0FE203DC}"/>
              </a:ext>
            </a:extLst>
          </p:cNvPr>
          <p:cNvSpPr txBox="1"/>
          <p:nvPr/>
        </p:nvSpPr>
        <p:spPr>
          <a:xfrm>
            <a:off x="8595360" y="4962290"/>
            <a:ext cx="3123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P CREB (43 KDa)</a:t>
            </a:r>
          </a:p>
        </p:txBody>
      </p:sp>
      <p:pic>
        <p:nvPicPr>
          <p:cNvPr id="10" name="Image 9">
            <a:extLst>
              <a:ext uri="{FF2B5EF4-FFF2-40B4-BE49-F238E27FC236}">
                <a16:creationId xmlns:a16="http://schemas.microsoft.com/office/drawing/2014/main" id="{0E05C367-7E57-0694-94D0-0288E894B8E1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9666" y="1526378"/>
            <a:ext cx="4523606" cy="3228144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E4A66CBE-6F76-E0C1-1FE0-1A1FBB9D573A}"/>
              </a:ext>
            </a:extLst>
          </p:cNvPr>
          <p:cNvSpPr txBox="1"/>
          <p:nvPr/>
        </p:nvSpPr>
        <p:spPr>
          <a:xfrm>
            <a:off x="1323833" y="2197290"/>
            <a:ext cx="39578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500" dirty="0"/>
              <a:t>50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C979FC42-3C32-C15A-B005-82ABF6D8C66C}"/>
              </a:ext>
            </a:extLst>
          </p:cNvPr>
          <p:cNvSpPr txBox="1"/>
          <p:nvPr/>
        </p:nvSpPr>
        <p:spPr>
          <a:xfrm>
            <a:off x="1323832" y="2520455"/>
            <a:ext cx="39578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500" dirty="0"/>
              <a:t>37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BE724C2B-C0C3-8CA2-304A-B86BB340299C}"/>
              </a:ext>
            </a:extLst>
          </p:cNvPr>
          <p:cNvSpPr txBox="1"/>
          <p:nvPr/>
        </p:nvSpPr>
        <p:spPr>
          <a:xfrm>
            <a:off x="1323831" y="2358872"/>
            <a:ext cx="39578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500" dirty="0"/>
              <a:t>43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EB560CA9-78DF-1F58-E676-1CCB1C61F19F}"/>
              </a:ext>
            </a:extLst>
          </p:cNvPr>
          <p:cNvSpPr txBox="1"/>
          <p:nvPr/>
        </p:nvSpPr>
        <p:spPr>
          <a:xfrm>
            <a:off x="2470244" y="4962290"/>
            <a:ext cx="3123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CREB (43 KDa)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C44B7FE7-3A71-DAD5-D25F-655CF4B70274}"/>
              </a:ext>
            </a:extLst>
          </p:cNvPr>
          <p:cNvSpPr txBox="1"/>
          <p:nvPr/>
        </p:nvSpPr>
        <p:spPr>
          <a:xfrm rot="18901592">
            <a:off x="2055685" y="1025400"/>
            <a:ext cx="73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Susp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863EAC2E-E97F-875E-FFE4-9ACD81A86D88}"/>
              </a:ext>
            </a:extLst>
          </p:cNvPr>
          <p:cNvSpPr txBox="1"/>
          <p:nvPr/>
        </p:nvSpPr>
        <p:spPr>
          <a:xfrm rot="18997719">
            <a:off x="2501201" y="966210"/>
            <a:ext cx="875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PMA 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66581F5D-CF5D-AB7B-0D30-DA85FACFA207}"/>
              </a:ext>
            </a:extLst>
          </p:cNvPr>
          <p:cNvSpPr txBox="1"/>
          <p:nvPr/>
        </p:nvSpPr>
        <p:spPr>
          <a:xfrm rot="19279151">
            <a:off x="2791965" y="673002"/>
            <a:ext cx="18910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uM  EGCG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DF7AE953-210A-CCFE-1F99-F5BB4424EDBD}"/>
              </a:ext>
            </a:extLst>
          </p:cNvPr>
          <p:cNvSpPr txBox="1"/>
          <p:nvPr/>
        </p:nvSpPr>
        <p:spPr>
          <a:xfrm rot="19231905">
            <a:off x="3190776" y="717204"/>
            <a:ext cx="19943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uM  EGCG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7098BE2E-6C71-8B86-D64A-8D2437FC793A}"/>
              </a:ext>
            </a:extLst>
          </p:cNvPr>
          <p:cNvSpPr txBox="1"/>
          <p:nvPr/>
        </p:nvSpPr>
        <p:spPr>
          <a:xfrm rot="19231905">
            <a:off x="3711564" y="694197"/>
            <a:ext cx="20102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0uM  EGCG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609FA292-038A-5B79-A3E0-4253D6D74EE3}"/>
              </a:ext>
            </a:extLst>
          </p:cNvPr>
          <p:cNvSpPr txBox="1"/>
          <p:nvPr/>
        </p:nvSpPr>
        <p:spPr>
          <a:xfrm rot="19231905">
            <a:off x="4225060" y="750077"/>
            <a:ext cx="197921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0uM  EGCG</a:t>
            </a:r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DD75CC71-5896-2C25-1CD4-4D504890A038}"/>
              </a:ext>
            </a:extLst>
          </p:cNvPr>
          <p:cNvSpPr txBox="1"/>
          <p:nvPr/>
        </p:nvSpPr>
        <p:spPr>
          <a:xfrm>
            <a:off x="1233841" y="1240683"/>
            <a:ext cx="6562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KDa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0159ECCC-DC83-C975-1C4F-04A0132A42A4}"/>
              </a:ext>
            </a:extLst>
          </p:cNvPr>
          <p:cNvSpPr txBox="1"/>
          <p:nvPr/>
        </p:nvSpPr>
        <p:spPr>
          <a:xfrm rot="18901592">
            <a:off x="7758624" y="1000831"/>
            <a:ext cx="7365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Susp</a:t>
            </a:r>
          </a:p>
        </p:txBody>
      </p:sp>
      <p:sp>
        <p:nvSpPr>
          <p:cNvPr id="36" name="ZoneTexte 35">
            <a:extLst>
              <a:ext uri="{FF2B5EF4-FFF2-40B4-BE49-F238E27FC236}">
                <a16:creationId xmlns:a16="http://schemas.microsoft.com/office/drawing/2014/main" id="{7CCA59A8-BA55-9BC5-4DCC-D592BBC475A4}"/>
              </a:ext>
            </a:extLst>
          </p:cNvPr>
          <p:cNvSpPr txBox="1"/>
          <p:nvPr/>
        </p:nvSpPr>
        <p:spPr>
          <a:xfrm rot="18997719">
            <a:off x="8275742" y="974788"/>
            <a:ext cx="8753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/>
              <a:t>PMA </a:t>
            </a:r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78DF8286-88EF-8D16-CB01-1EE180A21DF5}"/>
              </a:ext>
            </a:extLst>
          </p:cNvPr>
          <p:cNvSpPr txBox="1"/>
          <p:nvPr/>
        </p:nvSpPr>
        <p:spPr>
          <a:xfrm rot="19279151">
            <a:off x="8667939" y="666570"/>
            <a:ext cx="1891060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uM  EGCG</a:t>
            </a:r>
          </a:p>
        </p:txBody>
      </p:sp>
      <p:sp>
        <p:nvSpPr>
          <p:cNvPr id="40" name="ZoneTexte 39">
            <a:extLst>
              <a:ext uri="{FF2B5EF4-FFF2-40B4-BE49-F238E27FC236}">
                <a16:creationId xmlns:a16="http://schemas.microsoft.com/office/drawing/2014/main" id="{A4435A9F-2825-1FFD-9A56-9E13D285EC44}"/>
              </a:ext>
            </a:extLst>
          </p:cNvPr>
          <p:cNvSpPr txBox="1"/>
          <p:nvPr/>
        </p:nvSpPr>
        <p:spPr>
          <a:xfrm rot="19231905">
            <a:off x="9249671" y="614564"/>
            <a:ext cx="199433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uM  EGCG</a:t>
            </a:r>
          </a:p>
        </p:txBody>
      </p:sp>
      <p:sp>
        <p:nvSpPr>
          <p:cNvPr id="42" name="ZoneTexte 41">
            <a:extLst>
              <a:ext uri="{FF2B5EF4-FFF2-40B4-BE49-F238E27FC236}">
                <a16:creationId xmlns:a16="http://schemas.microsoft.com/office/drawing/2014/main" id="{239F18E6-B9A8-7BAF-EA4A-AB9CA992E573}"/>
              </a:ext>
            </a:extLst>
          </p:cNvPr>
          <p:cNvSpPr txBox="1"/>
          <p:nvPr/>
        </p:nvSpPr>
        <p:spPr>
          <a:xfrm rot="19231905">
            <a:off x="9811968" y="609500"/>
            <a:ext cx="2010263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10uM  EGCG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58DA4818-B7B6-D2A1-E7FC-17608CBD836D}"/>
              </a:ext>
            </a:extLst>
          </p:cNvPr>
          <p:cNvSpPr txBox="1"/>
          <p:nvPr/>
        </p:nvSpPr>
        <p:spPr>
          <a:xfrm rot="19231905">
            <a:off x="10365001" y="701763"/>
            <a:ext cx="203406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PMA +30uM  EGCG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44C2A705-A43E-25F0-4D63-53576C2C69AE}"/>
              </a:ext>
            </a:extLst>
          </p:cNvPr>
          <p:cNvSpPr txBox="1"/>
          <p:nvPr/>
        </p:nvSpPr>
        <p:spPr>
          <a:xfrm>
            <a:off x="7357637" y="1124754"/>
            <a:ext cx="656285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sz="1400" dirty="0"/>
              <a:t>KDa</a:t>
            </a:r>
          </a:p>
        </p:txBody>
      </p:sp>
      <p:sp>
        <p:nvSpPr>
          <p:cNvPr id="48" name="ZoneTexte 47">
            <a:extLst>
              <a:ext uri="{FF2B5EF4-FFF2-40B4-BE49-F238E27FC236}">
                <a16:creationId xmlns:a16="http://schemas.microsoft.com/office/drawing/2014/main" id="{482676F2-7FF7-A4D7-97B7-99E021B7386C}"/>
              </a:ext>
            </a:extLst>
          </p:cNvPr>
          <p:cNvSpPr txBox="1"/>
          <p:nvPr/>
        </p:nvSpPr>
        <p:spPr>
          <a:xfrm>
            <a:off x="56233" y="80215"/>
            <a:ext cx="12675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fr-FR" b="1" dirty="0"/>
              <a:t>Figure 3C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37D6DDA6-C0E3-672E-276B-85ABD15ADBAD}"/>
              </a:ext>
            </a:extLst>
          </p:cNvPr>
          <p:cNvSpPr txBox="1"/>
          <p:nvPr/>
        </p:nvSpPr>
        <p:spPr>
          <a:xfrm>
            <a:off x="6961852" y="2817285"/>
            <a:ext cx="39578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500" dirty="0"/>
              <a:t>37</a:t>
            </a:r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18DD7FFC-F25E-A158-21BD-FD43EC2F1425}"/>
              </a:ext>
            </a:extLst>
          </p:cNvPr>
          <p:cNvSpPr txBox="1"/>
          <p:nvPr/>
        </p:nvSpPr>
        <p:spPr>
          <a:xfrm>
            <a:off x="6961852" y="2645357"/>
            <a:ext cx="39578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500" dirty="0"/>
              <a:t>43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4718EBAA-C4B2-FAA5-637A-C6DE1323950C}"/>
              </a:ext>
            </a:extLst>
          </p:cNvPr>
          <p:cNvSpPr txBox="1"/>
          <p:nvPr/>
        </p:nvSpPr>
        <p:spPr>
          <a:xfrm>
            <a:off x="6961852" y="2473429"/>
            <a:ext cx="395785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500" dirty="0"/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181859484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4</TotalTime>
  <Words>308</Words>
  <Application>Microsoft Office PowerPoint</Application>
  <PresentationFormat>Widescreen</PresentationFormat>
  <Paragraphs>10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assouri, Celia</dc:creator>
  <cp:lastModifiedBy>MDPI</cp:lastModifiedBy>
  <cp:revision>5</cp:revision>
  <dcterms:created xsi:type="dcterms:W3CDTF">2022-09-14T14:11:53Z</dcterms:created>
  <dcterms:modified xsi:type="dcterms:W3CDTF">2022-10-16T08:57:21Z</dcterms:modified>
</cp:coreProperties>
</file>